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E5BB8-1097-4DB9-9D31-D87DEC7A21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20B8E-E743-4C48-8E54-84E9E1B37F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9930E-4E95-4F68-A4F7-10E2936C40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AE7FE-C950-4136-9A5A-8287AD1833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D9759-5E6B-41EC-B1BA-049BEDF869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2ECFF-E4A6-441D-8754-8707AE4E48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63FED-F845-4FCD-8916-F7770B2CE6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B2817-8392-461D-99E7-64659D1A9D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FA3C9-52E9-41AA-A5D0-849A8665D5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D5DB6-B024-4D92-94F7-56E7DCC2A4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85327F-D4F2-49A1-97B9-EE8BCA9E78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98F7B-7B78-4916-A558-C96D2F533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30823B-FD93-4E44-A7E3-98B38F4C3EC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5.png"/><Relationship Id="rId2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846440" y="5708520"/>
            <a:ext cx="1879560" cy="1368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846440" y="5908680"/>
            <a:ext cx="4165560" cy="1350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1846440" y="6095880"/>
            <a:ext cx="2706480" cy="1368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1846440" y="6296040"/>
            <a:ext cx="2539800" cy="1364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1486080" y="944640"/>
            <a:ext cx="2552400" cy="1350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tretch/>
        </p:blipFill>
        <p:spPr>
          <a:xfrm>
            <a:off x="1486080" y="1160640"/>
            <a:ext cx="2616120" cy="1364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7"/>
          <a:stretch/>
        </p:blipFill>
        <p:spPr>
          <a:xfrm>
            <a:off x="1486080" y="1808280"/>
            <a:ext cx="2628720" cy="13644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8"/>
          <a:stretch/>
        </p:blipFill>
        <p:spPr>
          <a:xfrm>
            <a:off x="1846440" y="5103720"/>
            <a:ext cx="3722400" cy="13500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9"/>
          <a:stretch/>
        </p:blipFill>
        <p:spPr>
          <a:xfrm>
            <a:off x="1486080" y="2241720"/>
            <a:ext cx="3593880" cy="13464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10"/>
          <a:stretch/>
        </p:blipFill>
        <p:spPr>
          <a:xfrm>
            <a:off x="1486080" y="2455920"/>
            <a:ext cx="6667200" cy="13644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11"/>
          <a:stretch/>
        </p:blipFill>
        <p:spPr>
          <a:xfrm>
            <a:off x="1486080" y="2671920"/>
            <a:ext cx="2882880" cy="1364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12"/>
          <a:stretch/>
        </p:blipFill>
        <p:spPr>
          <a:xfrm>
            <a:off x="1486080" y="2889360"/>
            <a:ext cx="4279680" cy="13500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13"/>
          <a:stretch/>
        </p:blipFill>
        <p:spPr>
          <a:xfrm>
            <a:off x="1486080" y="3103560"/>
            <a:ext cx="3886200" cy="13644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14"/>
          <a:stretch/>
        </p:blipFill>
        <p:spPr>
          <a:xfrm>
            <a:off x="1486080" y="3319560"/>
            <a:ext cx="3530520" cy="13644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15"/>
          <a:stretch/>
        </p:blipFill>
        <p:spPr>
          <a:xfrm>
            <a:off x="1486080" y="3537000"/>
            <a:ext cx="5117760" cy="13500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16"/>
          <a:stretch/>
        </p:blipFill>
        <p:spPr>
          <a:xfrm>
            <a:off x="1486080" y="3751200"/>
            <a:ext cx="3593880" cy="13644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17"/>
          <a:stretch/>
        </p:blipFill>
        <p:spPr>
          <a:xfrm>
            <a:off x="1486080" y="3968640"/>
            <a:ext cx="2374560" cy="13500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8"/>
          <a:stretch/>
        </p:blipFill>
        <p:spPr>
          <a:xfrm>
            <a:off x="1486080" y="4618080"/>
            <a:ext cx="2565360" cy="13500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9"/>
          <a:stretch/>
        </p:blipFill>
        <p:spPr>
          <a:xfrm>
            <a:off x="1486080" y="4398840"/>
            <a:ext cx="2565360" cy="13680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0"/>
          <a:stretch/>
        </p:blipFill>
        <p:spPr>
          <a:xfrm>
            <a:off x="1846440" y="5300640"/>
            <a:ext cx="1944360" cy="13644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21"/>
          <a:stretch/>
        </p:blipFill>
        <p:spPr>
          <a:xfrm>
            <a:off x="1486080" y="4184640"/>
            <a:ext cx="5117760" cy="13500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2"/>
          <a:stretch/>
        </p:blipFill>
        <p:spPr>
          <a:xfrm>
            <a:off x="1846440" y="5500800"/>
            <a:ext cx="2350800" cy="13644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3"/>
          <a:stretch/>
        </p:blipFill>
        <p:spPr>
          <a:xfrm>
            <a:off x="1486080" y="1593720"/>
            <a:ext cx="2171520" cy="1350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475560" y="9446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065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75560" y="11588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11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75560" y="13730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13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75560" y="15890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4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75560" y="18032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49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75560" y="20178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6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75560" y="22320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8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75560" y="24462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75560" y="26622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9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75560" y="28764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9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75560" y="30924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9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75560" y="33066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99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75560" y="35211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0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75560" y="37368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0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5560" y="39513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2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75560" y="41655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6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75560" y="43797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2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75560" y="45957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2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66720" y="510372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27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66720" y="52974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2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66720" y="551340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8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66720" y="569592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3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66720" y="589104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01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66720" y="607536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02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66720" y="6270480"/>
            <a:ext cx="75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e_02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1486080" y="1376280"/>
            <a:ext cx="7397280" cy="136440"/>
            <a:chOff x="1486080" y="1376280"/>
            <a:chExt cx="7397280" cy="136440"/>
          </a:xfrm>
        </p:grpSpPr>
        <p:pic>
          <p:nvPicPr>
            <p:cNvPr id="90" name="" descr=""/>
            <p:cNvPicPr/>
            <p:nvPr/>
          </p:nvPicPr>
          <p:blipFill>
            <a:blip r:embed="rId24"/>
            <a:srcRect l="0" t="0" r="20393" b="0"/>
            <a:stretch/>
          </p:blipFill>
          <p:spPr>
            <a:xfrm>
              <a:off x="1486080" y="1376280"/>
              <a:ext cx="7310520" cy="136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" descr=""/>
            <p:cNvPicPr/>
            <p:nvPr/>
          </p:nvPicPr>
          <p:blipFill>
            <a:blip r:embed="rId25"/>
            <a:srcRect l="99054" t="0" r="0" b="0"/>
            <a:stretch/>
          </p:blipFill>
          <p:spPr>
            <a:xfrm>
              <a:off x="8796600" y="1376280"/>
              <a:ext cx="86760" cy="136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92" name=""/>
          <p:cNvGrpSpPr/>
          <p:nvPr/>
        </p:nvGrpSpPr>
        <p:grpSpPr>
          <a:xfrm>
            <a:off x="1486080" y="1969920"/>
            <a:ext cx="7319520" cy="271800"/>
            <a:chOff x="1486080" y="1969920"/>
            <a:chExt cx="7319520" cy="271800"/>
          </a:xfrm>
        </p:grpSpPr>
        <p:pic>
          <p:nvPicPr>
            <p:cNvPr id="93" name="" descr=""/>
            <p:cNvPicPr/>
            <p:nvPr/>
          </p:nvPicPr>
          <p:blipFill>
            <a:blip r:embed="rId26"/>
            <a:srcRect l="0" t="0" r="26416" b="0"/>
            <a:stretch/>
          </p:blipFill>
          <p:spPr>
            <a:xfrm>
              <a:off x="1486080" y="2023560"/>
              <a:ext cx="5963040" cy="136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" descr=""/>
            <p:cNvPicPr/>
            <p:nvPr/>
          </p:nvPicPr>
          <p:blipFill>
            <a:blip r:embed="rId27"/>
            <a:srcRect l="72636" t="0" r="0" b="0"/>
            <a:stretch/>
          </p:blipFill>
          <p:spPr>
            <a:xfrm>
              <a:off x="6589440" y="2025000"/>
              <a:ext cx="2216160" cy="13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"/>
            <p:cNvSpPr/>
            <p:nvPr/>
          </p:nvSpPr>
          <p:spPr>
            <a:xfrm>
              <a:off x="6492240" y="1969920"/>
              <a:ext cx="179280" cy="271800"/>
            </a:xfrm>
            <a:custGeom>
              <a:avLst/>
              <a:gdLst/>
              <a:ahLst/>
              <a:rect l="l" t="t" r="r" b="b"/>
              <a:pathLst>
                <a:path w="136" h="227">
                  <a:moveTo>
                    <a:pt x="45" y="0"/>
                  </a:moveTo>
                  <a:lnTo>
                    <a:pt x="0" y="91"/>
                  </a:lnTo>
                  <a:lnTo>
                    <a:pt x="45" y="137"/>
                  </a:lnTo>
                  <a:lnTo>
                    <a:pt x="0" y="227"/>
                  </a:lnTo>
                  <a:lnTo>
                    <a:pt x="90" y="227"/>
                  </a:lnTo>
                  <a:lnTo>
                    <a:pt x="136" y="137"/>
                  </a:lnTo>
                  <a:lnTo>
                    <a:pt x="90" y="91"/>
                  </a:lnTo>
                  <a:lnTo>
                    <a:pt x="136" y="0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"/>
          <p:cNvSpPr/>
          <p:nvPr/>
        </p:nvSpPr>
        <p:spPr>
          <a:xfrm>
            <a:off x="347760" y="4994280"/>
            <a:ext cx="5952960" cy="15667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827560" y="13222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827560" y="19699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426920" y="26193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387400" y="30510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119200" y="36990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002560" y="32670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636960" y="34830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636960" y="41324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38920" y="45640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138920" y="43466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675400" y="5049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774600" y="52610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236480" y="54752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755520" y="5643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982840" y="58546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523760" y="60706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426920" y="62373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171280" y="24033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17T02:05:35Z</dcterms:created>
  <dc:creator>LTaylor</dc:creator>
  <dc:description/>
  <dc:language>en-US</dc:language>
  <cp:lastModifiedBy>LTaylor</cp:lastModifiedBy>
  <dcterms:modified xsi:type="dcterms:W3CDTF">2008-04-17T02:05:48Z</dcterms:modified>
  <cp:revision>1</cp:revision>
  <dc:subject/>
  <dc:title>Slide 1</dc:title>
</cp:coreProperties>
</file>